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1DDFF"/>
    <a:srgbClr val="4FE6FF"/>
    <a:srgbClr val="003A5D"/>
    <a:srgbClr val="00BFD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53"/>
    <p:restoredTop sz="94654"/>
  </p:normalViewPr>
  <p:slideViewPr>
    <p:cSldViewPr snapToGrid="0" snapToObjects="1">
      <p:cViewPr varScale="1">
        <p:scale>
          <a:sx n="78" d="100"/>
          <a:sy n="78" d="100"/>
        </p:scale>
        <p:origin x="586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napToObjects="1" showGuides="1">
      <p:cViewPr varScale="1">
        <p:scale>
          <a:sx n="62" d="100"/>
          <a:sy n="62" d="100"/>
        </p:scale>
        <p:origin x="3154" y="72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88FD3E-1513-4922-836E-69C1F2565848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5979F9-6F6C-4B1C-8474-9809D7DAE2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6379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5979F9-6F6C-4B1C-8474-9809D7DAE21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4548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560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486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223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102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9777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029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834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7925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11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5088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617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805A4-B662-294F-9DA1-5D9B91FD62B8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5196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sv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sv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6AB67B-F644-49E3-B9C9-2951F830C7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74581" y="0"/>
            <a:ext cx="11642838" cy="1137055"/>
          </a:xfrm>
        </p:spPr>
        <p:txBody>
          <a:bodyPr>
            <a:normAutofit/>
          </a:bodyPr>
          <a:lstStyle/>
          <a:p>
            <a:pPr algn="ctr"/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New Biparietal Bipolar Catheter Prototype for Hybrid Atrial Fibrillation Ablation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D54CF4FF-198F-4038-A94A-73E2DD96E73F}"/>
              </a:ext>
            </a:extLst>
          </p:cNvPr>
          <p:cNvGrpSpPr/>
          <p:nvPr/>
        </p:nvGrpSpPr>
        <p:grpSpPr>
          <a:xfrm>
            <a:off x="274581" y="1137055"/>
            <a:ext cx="11642838" cy="4453641"/>
            <a:chOff x="274581" y="1137055"/>
            <a:chExt cx="11642838" cy="4453641"/>
          </a:xfrm>
        </p:grpSpPr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8A66F968-4A60-40CC-ABF8-1715250DD3A4}"/>
                </a:ext>
              </a:extLst>
            </p:cNvPr>
            <p:cNvSpPr/>
            <p:nvPr/>
          </p:nvSpPr>
          <p:spPr>
            <a:xfrm>
              <a:off x="274581" y="1137055"/>
              <a:ext cx="3880946" cy="4453641"/>
            </a:xfrm>
            <a:prstGeom prst="rect">
              <a:avLst/>
            </a:prstGeom>
            <a:solidFill>
              <a:srgbClr val="00BFD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UDY METHODS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ustom-made radiofrequency biparietal bipolar ablation catheter in single-stage setting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enerate linear lesions around left atrium and pulmonary veins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resh porcine hearts (</a:t>
              </a:r>
              <a:r>
                <a:rPr lang="en-US" sz="2000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=5) </a:t>
              </a: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ith one ablation each</a:t>
              </a:r>
            </a:p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C2BD41FA-277E-48C9-A86D-24E908BEAB43}"/>
                </a:ext>
              </a:extLst>
            </p:cNvPr>
            <p:cNvSpPr/>
            <p:nvPr/>
          </p:nvSpPr>
          <p:spPr>
            <a:xfrm>
              <a:off x="4155527" y="1137055"/>
              <a:ext cx="3880946" cy="4453641"/>
            </a:xfrm>
            <a:prstGeom prst="rect">
              <a:avLst/>
            </a:prstGeom>
            <a:solidFill>
              <a:srgbClr val="11DD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OTOTYPE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2BDD0B3E-97C4-4961-85FC-17F984B231B4}"/>
                </a:ext>
              </a:extLst>
            </p:cNvPr>
            <p:cNvSpPr/>
            <p:nvPr/>
          </p:nvSpPr>
          <p:spPr>
            <a:xfrm>
              <a:off x="8036473" y="1137055"/>
              <a:ext cx="3880946" cy="4453641"/>
            </a:xfrm>
            <a:prstGeom prst="rect">
              <a:avLst/>
            </a:prstGeom>
            <a:solidFill>
              <a:srgbClr val="00BFD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UTCOME</a:t>
              </a:r>
            </a:p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% transmural ablations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inuous linear lesions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rue one-step hybrid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xt step is to enhance the</a:t>
              </a: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esign for clinical application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F1067D66-3B18-4C13-BE99-9FADBCAC927E}"/>
              </a:ext>
            </a:extLst>
          </p:cNvPr>
          <p:cNvGrpSpPr/>
          <p:nvPr/>
        </p:nvGrpSpPr>
        <p:grpSpPr>
          <a:xfrm>
            <a:off x="274581" y="5590696"/>
            <a:ext cx="11642838" cy="1267304"/>
            <a:chOff x="274581" y="5590696"/>
            <a:chExt cx="11642838" cy="1267304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5C1BC0D-3D40-4F7D-9935-BB8BC885EA74}"/>
                </a:ext>
              </a:extLst>
            </p:cNvPr>
            <p:cNvSpPr txBox="1"/>
            <p:nvPr/>
          </p:nvSpPr>
          <p:spPr>
            <a:xfrm>
              <a:off x="3204022" y="6627168"/>
              <a:ext cx="577754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@Innovationsjour | Copyright © The Author(s) 2021. All rights reserved. Published by SAGE Publishing Inc.</a:t>
              </a:r>
            </a:p>
          </p:txBody>
        </p:sp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0300ED5C-CD19-4926-A571-D5CC9C00EE6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4581" y="5590696"/>
              <a:ext cx="11642838" cy="1036472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A0A69DF-628C-48B0-9981-44EBE0D1E2AA}"/>
                </a:ext>
              </a:extLst>
            </p:cNvPr>
            <p:cNvSpPr txBox="1"/>
            <p:nvPr/>
          </p:nvSpPr>
          <p:spPr>
            <a:xfrm>
              <a:off x="4026773" y="6280919"/>
              <a:ext cx="4781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tteucci</a:t>
              </a:r>
              <a:r>
                <a:rPr lang="en-US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et al. </a:t>
              </a:r>
              <a:r>
                <a:rPr lang="en-US" sz="14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novations</a:t>
              </a:r>
              <a:r>
                <a:rPr lang="en-US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 March/April 2021.</a:t>
              </a:r>
            </a:p>
          </p:txBody>
        </p:sp>
      </p:grpSp>
      <p:pic>
        <p:nvPicPr>
          <p:cNvPr id="11" name="Picture 2" descr="Picture 2">
            <a:extLst>
              <a:ext uri="{FF2B5EF4-FFF2-40B4-BE49-F238E27FC236}">
                <a16:creationId xmlns:a16="http://schemas.microsoft.com/office/drawing/2014/main" id="{D4669D63-7FFC-4E9B-8ECA-47741FBECE4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24618" y="2002368"/>
            <a:ext cx="2342764" cy="3437623"/>
          </a:xfrm>
          <a:prstGeom prst="rect">
            <a:avLst/>
          </a:prstGeom>
          <a:ln w="12700">
            <a:miter lim="400000"/>
          </a:ln>
        </p:spPr>
      </p:pic>
      <p:pic>
        <p:nvPicPr>
          <p:cNvPr id="22" name="Graphic 21">
            <a:extLst>
              <a:ext uri="{FF2B5EF4-FFF2-40B4-BE49-F238E27FC236}">
                <a16:creationId xmlns:a16="http://schemas.microsoft.com/office/drawing/2014/main" id="{9ECA26F8-13BF-4304-9073-87648751AFD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9245056" y="3496809"/>
            <a:ext cx="1452439" cy="1452439"/>
          </a:xfrm>
          <a:prstGeom prst="rect">
            <a:avLst/>
          </a:prstGeom>
        </p:spPr>
      </p:pic>
      <p:pic>
        <p:nvPicPr>
          <p:cNvPr id="35" name="Graphic 34">
            <a:extLst>
              <a:ext uri="{FF2B5EF4-FFF2-40B4-BE49-F238E27FC236}">
                <a16:creationId xmlns:a16="http://schemas.microsoft.com/office/drawing/2014/main" id="{98CA6252-A0C5-4939-AE83-14DEC851DB2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1796430" y="2933091"/>
            <a:ext cx="837248" cy="837248"/>
          </a:xfrm>
          <a:prstGeom prst="rect">
            <a:avLst/>
          </a:prstGeom>
        </p:spPr>
      </p:pic>
      <p:pic>
        <p:nvPicPr>
          <p:cNvPr id="38" name="Graphic 37">
            <a:extLst>
              <a:ext uri="{FF2B5EF4-FFF2-40B4-BE49-F238E27FC236}">
                <a16:creationId xmlns:a16="http://schemas.microsoft.com/office/drawing/2014/main" id="{E1EFC4EF-5906-4E6C-A5BB-89578E6350A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1796430" y="4147854"/>
            <a:ext cx="837248" cy="8372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15569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1</TotalTime>
  <Words>98</Words>
  <Application>Microsoft Office PowerPoint</Application>
  <PresentationFormat>Widescreen</PresentationFormat>
  <Paragraphs>3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New Biparietal Bipolar Catheter Prototype for Hybrid Atrial Fibrillation Abl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t Kiesel</dc:creator>
  <cp:lastModifiedBy>Holmes, Sari</cp:lastModifiedBy>
  <cp:revision>18</cp:revision>
  <dcterms:created xsi:type="dcterms:W3CDTF">2019-04-26T22:59:25Z</dcterms:created>
  <dcterms:modified xsi:type="dcterms:W3CDTF">2020-11-25T17:21:47Z</dcterms:modified>
</cp:coreProperties>
</file>